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EF1071-04EB-4234-B013-20DE0740591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232983-ADE7-478A-B14D-5731AD2EF9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936D2F-51EE-4113-8EFD-FDF34C91A0D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4B2674-2F84-423C-9C98-CAD0F58CF12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7401EB-917B-4673-A31C-5E84CDFC3E4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6C4E94-E454-4569-A54C-0CDE45C727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F7CEAD-F561-4C13-85CF-1F06505AF9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010C25-0613-4D30-89E6-19E67BC209C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935546-5889-46D4-B291-7E8065EDB3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5C320D-4BD8-4E38-AAB8-1D9BF16817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9E8389-0EE1-4AD0-B245-09EEDADEF7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052EDC-4A4E-46D3-8548-5F9C05B4B0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74F1FC5-E701-4D7B-AB77-5BEAF90FB380}" type="slidenum">
              <a:rPr b="0" lang="zh-TW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7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字方塊 3"/>
          <p:cNvSpPr/>
          <p:nvPr/>
        </p:nvSpPr>
        <p:spPr>
          <a:xfrm>
            <a:off x="1258920" y="2027160"/>
            <a:ext cx="29527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SC66     0             1             2              4             8 (</a:t>
            </a:r>
            <a:r>
              <a:rPr b="0" lang="el-GR" sz="1000" spc="-1" strike="noStrike">
                <a:solidFill>
                  <a:srgbClr val="000000"/>
                </a:solidFill>
                <a:latin typeface="Calibri"/>
              </a:rPr>
              <a:t>μ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DDP    0             5            10           20           30 (</a:t>
            </a:r>
            <a:r>
              <a:rPr b="0" lang="el-GR" sz="1000" spc="-1" strike="noStrike">
                <a:solidFill>
                  <a:srgbClr val="000000"/>
                </a:solidFill>
                <a:latin typeface="Calibri"/>
              </a:rPr>
              <a:t>μ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圖表 4" descr=""/>
          <p:cNvPicPr/>
          <p:nvPr/>
        </p:nvPicPr>
        <p:blipFill>
          <a:blip r:embed="rId1"/>
          <a:stretch/>
        </p:blipFill>
        <p:spPr>
          <a:xfrm>
            <a:off x="4127400" y="523800"/>
            <a:ext cx="2382840" cy="1586160"/>
          </a:xfrm>
          <a:prstGeom prst="rect">
            <a:avLst/>
          </a:prstGeom>
          <a:ln w="0">
            <a:noFill/>
          </a:ln>
        </p:spPr>
      </p:pic>
      <p:pic>
        <p:nvPicPr>
          <p:cNvPr id="43" name="圖表 5" descr=""/>
          <p:cNvPicPr/>
          <p:nvPr/>
        </p:nvPicPr>
        <p:blipFill>
          <a:blip r:embed="rId2"/>
          <a:stretch/>
        </p:blipFill>
        <p:spPr>
          <a:xfrm>
            <a:off x="1420920" y="512640"/>
            <a:ext cx="2359080" cy="1584360"/>
          </a:xfrm>
          <a:prstGeom prst="rect">
            <a:avLst/>
          </a:prstGeom>
          <a:ln w="0">
            <a:noFill/>
          </a:ln>
        </p:spPr>
      </p:pic>
      <p:pic>
        <p:nvPicPr>
          <p:cNvPr id="44" name="文字方塊 7" descr=""/>
          <p:cNvPicPr/>
          <p:nvPr/>
        </p:nvPicPr>
        <p:blipFill>
          <a:blip r:embed="rId3"/>
          <a:stretch/>
        </p:blipFill>
        <p:spPr>
          <a:xfrm>
            <a:off x="1127160" y="1060560"/>
            <a:ext cx="336600" cy="969840"/>
          </a:xfrm>
          <a:prstGeom prst="rect">
            <a:avLst/>
          </a:prstGeom>
          <a:ln w="0">
            <a:noFill/>
          </a:ln>
        </p:spPr>
      </p:pic>
      <p:pic>
        <p:nvPicPr>
          <p:cNvPr id="45" name="文字方塊 8" descr=""/>
          <p:cNvPicPr/>
          <p:nvPr/>
        </p:nvPicPr>
        <p:blipFill>
          <a:blip r:embed="rId4"/>
          <a:stretch/>
        </p:blipFill>
        <p:spPr>
          <a:xfrm>
            <a:off x="3870360" y="774720"/>
            <a:ext cx="341280" cy="968400"/>
          </a:xfrm>
          <a:prstGeom prst="rect">
            <a:avLst/>
          </a:prstGeom>
          <a:ln w="0">
            <a:noFill/>
          </a:ln>
        </p:spPr>
      </p:pic>
      <p:sp>
        <p:nvSpPr>
          <p:cNvPr id="46" name="文字方塊 9"/>
          <p:cNvSpPr/>
          <p:nvPr/>
        </p:nvSpPr>
        <p:spPr>
          <a:xfrm>
            <a:off x="1469880" y="260280"/>
            <a:ext cx="63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A2780/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文字方塊 10"/>
          <p:cNvSpPr/>
          <p:nvPr/>
        </p:nvSpPr>
        <p:spPr>
          <a:xfrm>
            <a:off x="4078440" y="268200"/>
            <a:ext cx="1028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A2780/COL11A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文字方塊 1"/>
          <p:cNvSpPr/>
          <p:nvPr/>
        </p:nvSpPr>
        <p:spPr>
          <a:xfrm>
            <a:off x="96120" y="-27000"/>
            <a:ext cx="2398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ry Figure 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圖表 13" descr=""/>
          <p:cNvPicPr/>
          <p:nvPr/>
        </p:nvPicPr>
        <p:blipFill>
          <a:blip r:embed="rId5"/>
          <a:stretch/>
        </p:blipFill>
        <p:spPr>
          <a:xfrm>
            <a:off x="4138560" y="2597040"/>
            <a:ext cx="2451240" cy="1590840"/>
          </a:xfrm>
          <a:prstGeom prst="rect">
            <a:avLst/>
          </a:prstGeom>
          <a:ln w="0">
            <a:noFill/>
          </a:ln>
        </p:spPr>
      </p:pic>
      <p:pic>
        <p:nvPicPr>
          <p:cNvPr id="50" name="圖表 15" descr=""/>
          <p:cNvPicPr/>
          <p:nvPr/>
        </p:nvPicPr>
        <p:blipFill>
          <a:blip r:embed="rId6"/>
          <a:stretch/>
        </p:blipFill>
        <p:spPr>
          <a:xfrm>
            <a:off x="1365120" y="2597040"/>
            <a:ext cx="2505240" cy="1590840"/>
          </a:xfrm>
          <a:prstGeom prst="rect">
            <a:avLst/>
          </a:prstGeom>
          <a:ln w="0">
            <a:noFill/>
          </a:ln>
        </p:spPr>
      </p:pic>
      <p:sp>
        <p:nvSpPr>
          <p:cNvPr id="51" name="文字方塊 3"/>
          <p:cNvSpPr/>
          <p:nvPr/>
        </p:nvSpPr>
        <p:spPr>
          <a:xfrm>
            <a:off x="3995640" y="2027160"/>
            <a:ext cx="29527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SC66     0            1              2              4             8 (</a:t>
            </a:r>
            <a:r>
              <a:rPr b="0" lang="el-GR" sz="1000" spc="-1" strike="noStrike">
                <a:solidFill>
                  <a:srgbClr val="000000"/>
                </a:solidFill>
                <a:latin typeface="Calibri"/>
              </a:rPr>
              <a:t>μ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DDP    0            5             10           20           30 (</a:t>
            </a:r>
            <a:r>
              <a:rPr b="0" lang="el-GR" sz="1000" spc="-1" strike="noStrike">
                <a:solidFill>
                  <a:srgbClr val="000000"/>
                </a:solidFill>
                <a:latin typeface="Calibri"/>
              </a:rPr>
              <a:t>μ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文字方塊 3"/>
          <p:cNvSpPr/>
          <p:nvPr/>
        </p:nvSpPr>
        <p:spPr>
          <a:xfrm>
            <a:off x="1258920" y="4075200"/>
            <a:ext cx="29527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SC66     0             1              2               4              8 (</a:t>
            </a:r>
            <a:r>
              <a:rPr b="0" lang="el-GR" sz="1000" spc="-1" strike="noStrike">
                <a:solidFill>
                  <a:srgbClr val="000000"/>
                </a:solidFill>
                <a:latin typeface="Calibri"/>
              </a:rPr>
              <a:t>μ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PAC       0             5             10            20            30 (</a:t>
            </a:r>
            <a:r>
              <a:rPr b="0" lang="el-GR" sz="1000" spc="-1" strike="noStrike">
                <a:solidFill>
                  <a:srgbClr val="000000"/>
                </a:solidFill>
                <a:latin typeface="Calibri"/>
              </a:rPr>
              <a:t>μ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文字方塊 3"/>
          <p:cNvSpPr/>
          <p:nvPr/>
        </p:nvSpPr>
        <p:spPr>
          <a:xfrm>
            <a:off x="4067280" y="4075200"/>
            <a:ext cx="29527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SC66     0            1             2              4             8 (</a:t>
            </a:r>
            <a:r>
              <a:rPr b="0" lang="el-GR" sz="1000" spc="-1" strike="noStrike">
                <a:solidFill>
                  <a:srgbClr val="000000"/>
                </a:solidFill>
                <a:latin typeface="Calibri"/>
              </a:rPr>
              <a:t>μ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PAC       0            5            10           20           30 (</a:t>
            </a:r>
            <a:r>
              <a:rPr b="0" lang="el-GR" sz="1000" spc="-1" strike="noStrike">
                <a:solidFill>
                  <a:srgbClr val="000000"/>
                </a:solidFill>
                <a:latin typeface="Calibri"/>
              </a:rPr>
              <a:t>μ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4" name="文字方塊 20" descr=""/>
          <p:cNvPicPr/>
          <p:nvPr/>
        </p:nvPicPr>
        <p:blipFill>
          <a:blip r:embed="rId7"/>
          <a:stretch/>
        </p:blipFill>
        <p:spPr>
          <a:xfrm>
            <a:off x="1116000" y="2816280"/>
            <a:ext cx="341280" cy="969840"/>
          </a:xfrm>
          <a:prstGeom prst="rect">
            <a:avLst/>
          </a:prstGeom>
          <a:ln w="0">
            <a:noFill/>
          </a:ln>
        </p:spPr>
      </p:pic>
      <p:pic>
        <p:nvPicPr>
          <p:cNvPr id="55" name="文字方塊 21" descr=""/>
          <p:cNvPicPr/>
          <p:nvPr/>
        </p:nvPicPr>
        <p:blipFill>
          <a:blip r:embed="rId8"/>
          <a:stretch/>
        </p:blipFill>
        <p:spPr>
          <a:xfrm>
            <a:off x="3870360" y="2816280"/>
            <a:ext cx="341280" cy="969840"/>
          </a:xfrm>
          <a:prstGeom prst="rect">
            <a:avLst/>
          </a:prstGeom>
          <a:ln w="0">
            <a:noFill/>
          </a:ln>
        </p:spPr>
      </p:pic>
      <p:sp>
        <p:nvSpPr>
          <p:cNvPr id="56" name="文字方塊 9"/>
          <p:cNvSpPr/>
          <p:nvPr/>
        </p:nvSpPr>
        <p:spPr>
          <a:xfrm>
            <a:off x="1481040" y="2374920"/>
            <a:ext cx="63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A2780/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文字方塊 10"/>
          <p:cNvSpPr/>
          <p:nvPr/>
        </p:nvSpPr>
        <p:spPr>
          <a:xfrm>
            <a:off x="4089600" y="2382840"/>
            <a:ext cx="1028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A2780/COL11A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58" name=""/>
          <p:cNvGraphicFramePr/>
          <p:nvPr/>
        </p:nvGraphicFramePr>
        <p:xfrm>
          <a:off x="930240" y="4475160"/>
          <a:ext cx="6564240" cy="2205000"/>
        </p:xfrm>
        <a:graphic>
          <a:graphicData uri="http://schemas.openxmlformats.org/drawingml/2006/table">
            <a:tbl>
              <a:tblPr/>
              <a:tblGrid>
                <a:gridCol w="1336680"/>
                <a:gridCol w="879480"/>
                <a:gridCol w="901800"/>
                <a:gridCol w="984240"/>
                <a:gridCol w="985680"/>
                <a:gridCol w="738360"/>
                <a:gridCol w="738000"/>
              </a:tblGrid>
              <a:tr h="264960">
                <a:tc>
                  <a:txBody>
                    <a:bodyPr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4"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C</a:t>
                      </a:r>
                      <a:r>
                        <a:rPr b="0" lang="en-US" sz="1000" spc="-1" strike="noStrike" baseline="-25000">
                          <a:solidFill>
                            <a:srgbClr val="000000"/>
                          </a:solidFill>
                          <a:latin typeface="Calibri"/>
                        </a:rPr>
                        <a:t>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4960">
                <a:tc>
                  <a:txBody>
                    <a:bodyPr lIns="68400" rIns="6840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Cell lin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ingl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ombina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 valu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I</a:t>
                      </a:r>
                      <a:r>
                        <a:rPr b="0" lang="en-US" sz="1000" spc="-1" strike="noStrike" baseline="-25000">
                          <a:solidFill>
                            <a:srgbClr val="000000"/>
                          </a:solidFill>
                          <a:latin typeface="Calibri"/>
                        </a:rPr>
                        <a:t>50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4080">
                <a:tc>
                  <a:txBody>
                    <a:bodyPr lIns="68400" rIns="6840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C6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DDP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C6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DDP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4080">
                <a:tc>
                  <a:txBody>
                    <a:bodyPr lIns="68400" rIns="6840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2780/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19±0.0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.74±0.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10±0.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.62±0.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3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3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4080">
                <a:tc>
                  <a:txBody>
                    <a:bodyPr lIns="68400" rIns="6840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2780/COL11A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.31±0.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8.91±0.5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07±0.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.99±0.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 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7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4960">
                <a:tc>
                  <a:txBody>
                    <a:bodyPr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ingl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ombina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 valu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I</a:t>
                      </a:r>
                      <a:r>
                        <a:rPr b="0" lang="en-US" sz="1000" spc="-1" strike="noStrike" baseline="-25000">
                          <a:solidFill>
                            <a:srgbClr val="000000"/>
                          </a:solidFill>
                          <a:latin typeface="Calibri"/>
                        </a:rPr>
                        <a:t>50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4080">
                <a:tc>
                  <a:txBody>
                    <a:bodyPr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C6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C6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4080">
                <a:tc>
                  <a:txBody>
                    <a:bodyPr lIns="68400" rIns="6840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2780/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08±0.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86±0.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04±0.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87±0.0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3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4080">
                <a:tc>
                  <a:txBody>
                    <a:bodyPr lIns="68400" rIns="6840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2780/COL11A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.04±0.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.70±0.7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02±0.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.70±0.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7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8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6-15T05:52:42Z</dcterms:created>
  <dc:creator>user</dc:creator>
  <dc:description/>
  <dc:language>en-US</dc:language>
  <cp:lastModifiedBy>user</cp:lastModifiedBy>
  <cp:lastPrinted>2019-01-25T02:36:55Z</cp:lastPrinted>
  <dcterms:modified xsi:type="dcterms:W3CDTF">2019-01-29T03:48:29Z</dcterms:modified>
  <cp:revision>1116</cp:revision>
  <dc:subject/>
  <dc:title>PowerPoint 簡報</dc:title>
</cp:coreProperties>
</file>